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822856-664A-4F7E-BC37-BEA85A992FE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ABA7A0-145F-4099-98BB-28D5396DA3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BDD668-9231-416E-A330-E91DD2A852D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6EADB0-9CA5-4AE1-AF67-F5D2600224B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828A98-D328-4D26-BEC3-D403BE74B1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9DB821-8245-4BDC-A55C-C07B863048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6E9065-3599-445E-897C-C14EB1028B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4DE4D7-F80D-46C3-93C6-CBB17278E2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AE9DB9-B86F-4D33-A374-B7AE5CA068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EAC52D-F20A-4335-B49E-0A49E28C16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09D055-589D-4C3F-A565-865DFF26C6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BF0CAC-D848-46F7-A6C6-25E02063A5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70DF88-DB29-426C-A1AA-D156706BF77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68360" y="1125360"/>
          <a:ext cx="8496360" cy="3245040"/>
        </p:xfrm>
        <a:graphic>
          <a:graphicData uri="http://schemas.openxmlformats.org/drawingml/2006/table">
            <a:tbl>
              <a:tblPr/>
              <a:tblGrid>
                <a:gridCol w="1295280"/>
                <a:gridCol w="3313080"/>
                <a:gridCol w="3168720"/>
                <a:gridCol w="719280"/>
              </a:tblGrid>
              <a:tr h="516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anscrip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rward prime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verse prime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b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UPL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31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mx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TGGACATCGGTTTCAAGG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GAACGGTCCGTGTAGTAGCA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31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xg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CGTATTACCGGGAGAAC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ACTCAAGTTGTGTCTGATGGA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31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fi1b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AAGAAACACACATTTATCCAC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GAATGCTTTTCCACACAC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3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r1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AACAAGGAGAAGCACAA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TCCTGCTGCTGGAACTC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31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hx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AGCGTGTGCCAAACAT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ACGTGTTCCGTATTTCCTG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31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lc6a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CCACTGGCTGCTTGTC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GGAATGTTGCTGTGAA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31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ox9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CCAGCATGGGAGAAGT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AGTTTTCGGGGTGGT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3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actin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GGCCAACAGGGAAAAG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GGTACGACCAGAGGCATA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031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pd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CTTTGGTATTGAGGAGGCTC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TTCTGTGTGGCGGTGTA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4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539640" y="5365080"/>
            <a:ext cx="7920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79056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 u="sng">
                <a:solidFill>
                  <a:srgbClr val="000000"/>
                </a:solidFill>
                <a:uFillTx/>
                <a:latin typeface="Arial"/>
              </a:rPr>
              <a:t>Additional data file 9.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rimer sequences and probe numbers (Universal Probe Library (Roche)) for quantitative real-time PCR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12T16:11:32Z</dcterms:created>
  <dc:creator>katharine.webb</dc:creator>
  <dc:description/>
  <dc:language>en-US</dc:language>
  <cp:lastModifiedBy>katharine.webb</cp:lastModifiedBy>
  <dcterms:modified xsi:type="dcterms:W3CDTF">2009-06-23T11:28:53Z</dcterms:modified>
  <cp:revision>5</cp:revision>
  <dc:subject/>
  <dc:title>Folie 1</dc:title>
</cp:coreProperties>
</file>